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1" r:id="rId2"/>
    <p:sldId id="262" r:id="rId3"/>
    <p:sldId id="263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B2DD7AA-D308-41EA-8F2C-4B39C188453C}" v="1" dt="2024-10-11T03:41:11.89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035" autoAdjust="0"/>
  </p:normalViewPr>
  <p:slideViewPr>
    <p:cSldViewPr snapToGrid="0">
      <p:cViewPr varScale="1">
        <p:scale>
          <a:sx n="57" d="100"/>
          <a:sy n="57" d="100"/>
        </p:scale>
        <p:origin x="97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ohan, Man" userId="37104710-05df-4370-9d86-514a293a6e2e" providerId="ADAL" clId="{4B2DD7AA-D308-41EA-8F2C-4B39C188453C}"/>
    <pc:docChg chg="custSel modSld">
      <pc:chgData name="Mohan, Man" userId="37104710-05df-4370-9d86-514a293a6e2e" providerId="ADAL" clId="{4B2DD7AA-D308-41EA-8F2C-4B39C188453C}" dt="2024-10-11T03:41:28.849" v="5" actId="20577"/>
      <pc:docMkLst>
        <pc:docMk/>
      </pc:docMkLst>
      <pc:sldChg chg="addSp delSp modSp mod">
        <pc:chgData name="Mohan, Man" userId="37104710-05df-4370-9d86-514a293a6e2e" providerId="ADAL" clId="{4B2DD7AA-D308-41EA-8F2C-4B39C188453C}" dt="2024-10-11T03:41:28.849" v="5" actId="20577"/>
        <pc:sldMkLst>
          <pc:docMk/>
          <pc:sldMk cId="624856637" sldId="261"/>
        </pc:sldMkLst>
        <pc:spChg chg="del">
          <ac:chgData name="Mohan, Man" userId="37104710-05df-4370-9d86-514a293a6e2e" providerId="ADAL" clId="{4B2DD7AA-D308-41EA-8F2C-4B39C188453C}" dt="2024-10-11T03:41:23.552" v="2" actId="478"/>
          <ac:spMkLst>
            <pc:docMk/>
            <pc:sldMk cId="624856637" sldId="261"/>
            <ac:spMk id="5" creationId="{98FAE3EA-C9CF-4D6F-83A9-7DC9835422F5}"/>
          </ac:spMkLst>
        </pc:spChg>
        <pc:spChg chg="add mod">
          <ac:chgData name="Mohan, Man" userId="37104710-05df-4370-9d86-514a293a6e2e" providerId="ADAL" clId="{4B2DD7AA-D308-41EA-8F2C-4B39C188453C}" dt="2024-10-11T03:41:28.849" v="5" actId="20577"/>
          <ac:spMkLst>
            <pc:docMk/>
            <pc:sldMk cId="624856637" sldId="261"/>
            <ac:spMk id="26" creationId="{8775C04E-35C0-63BE-043A-F996B649B51C}"/>
          </ac:spMkLst>
        </pc:spChg>
      </pc:sldChg>
    </pc:docChg>
  </pc:docChgLst>
  <pc:docChgLst>
    <pc:chgData name="Mohan, Man" userId="37104710-05df-4370-9d86-514a293a6e2e" providerId="ADAL" clId="{C5885A14-731A-4DAD-98A1-DF37E12512D2}"/>
    <pc:docChg chg="delSld">
      <pc:chgData name="Mohan, Man" userId="37104710-05df-4370-9d86-514a293a6e2e" providerId="ADAL" clId="{C5885A14-731A-4DAD-98A1-DF37E12512D2}" dt="2024-10-11T03:01:26.453" v="0" actId="47"/>
      <pc:docMkLst>
        <pc:docMk/>
      </pc:docMkLst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1121486319" sldId="256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4205977045" sldId="257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3414948269" sldId="258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3742170954" sldId="259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2234559543" sldId="260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1131492891" sldId="264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3674586638" sldId="265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1261270142" sldId="266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2399525343" sldId="267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2260216419" sldId="269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3194131882" sldId="270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3011352975" sldId="271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36225885" sldId="272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3140328593" sldId="273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669503856" sldId="274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3635091487" sldId="275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2458001602" sldId="281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285705100" sldId="282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1149221801" sldId="288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1285376761" sldId="500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3620413559" sldId="501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4122175436" sldId="502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1477486496" sldId="503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2721794196" sldId="504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4210385526" sldId="505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1656193735" sldId="506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504583-7B5D-40B4-9C6F-03C96B52897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1F89A4-67EE-4C74-A11B-3F43D8EA81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49495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BEA70D-3707-46A2-A485-AAE86DFEAED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7700330-E2EA-4D07-9D93-67104577479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1351315-0B1E-43F9-9181-336A19B8DE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60363D5-A7B9-4777-93AE-2F78C0E599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A5CC34B-092D-4C7A-ABA2-7552E9E89B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6067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AD26CF-1A19-45F2-B9DE-47DACDF40F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606D00C-F753-487F-8B5C-1AE84AF893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6689296-4539-4176-8256-C61131A77D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22E0E34-1DD3-4652-86A3-272AD902A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4E8106D-F029-4780-9715-81C5A3FD30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4385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F712C04-2146-4D64-8941-528041968BC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7675B9D-DC94-4AB1-ADC7-1BD6803BC2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54F9DBB-0DCF-49BD-A524-63B900121F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636DF19-A71D-406E-83ED-36C474FFFB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2EE3502-7F4C-40E8-9072-8D28BB2BFC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79413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9A59159-B982-4394-B832-096011BD71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255ADB8-D7D1-4FA2-8B4D-5DAB5EC21C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DE22A4-94EA-4DE4-A2F6-1DAA60B4DA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8E490B2-C4E2-4EF1-BEEB-035A80420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1403662-B430-46BC-84C7-D808814BBD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9642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886453-A168-4680-9E8C-2D74DDE3FA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D60B88F-6DCF-40CB-B65D-D2BA7229B5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DC47B9E-13A4-4FFB-98B3-5200E2BE2F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B615512-68D1-4687-A658-0DFE754D8E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9D8E0FE-E8F3-4654-8656-476144260C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9236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DF2729F-3944-4F03-8032-39F1881B0C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3580B50-8709-4DC7-931B-352534FAC2E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6A69BC4-6C28-435C-BEC9-37327CD357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11C899A-4A23-4DC8-9263-3AC9662522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9F9BEAA-D690-4733-A7B5-CE9BC17AF0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7251231-C7BD-4230-8B08-2A2F9FAB3C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96663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7986141-A74D-4E71-AD24-48A53384D7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117FE55-8D4B-4B3F-9FC0-400251B83D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1E5E27D-98DE-46D6-BF5D-57A3AAD70E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A70CE71-2E40-46E3-B367-23C8A8B210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22EBE65-BAD6-4ED3-8E88-A0CA6FDBC6D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43C7EFC-D303-40E7-B4A4-A2C6BFDD3C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B705BD2-8602-47E6-A9E6-4656F4AB85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BB80679-178B-4860-852C-CFE1D4F7F2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07631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9F88B0-9D19-4FF4-9AC7-77BACEDD47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E367C5E-C6BC-400A-BB13-5D0E2F508A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A2583F3-DC24-4165-88D9-FF7F5600F1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576730E-E551-423C-BD86-5115AF82BE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2812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FD1F254-FC85-4D1C-AF6C-8DE072BD73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902D72B-1EEE-4861-8A8B-5306427226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5538E7B-789C-49FA-805A-C1529D404C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8202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0470EA-7D03-4725-BA05-E7CE1E37B3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F257138-28FB-406B-8438-46576CF45C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5810CDF-550A-47EC-BCFD-81389CE8B4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212A10F-B061-4FBD-ADDF-DD9DCCA9CC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34E30AC-E221-4572-99C0-A2FE3705FE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398A571-57FC-44B6-AA2A-D252676045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49282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C7F52C-996E-4B46-9605-FFFFA8F3CE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7F9AB88-D2AF-4315-87D0-C91C24BC190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CDF98DF-667B-425A-9325-7B86ECD841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F2C9590-6A3B-472D-89D3-D2D5DBCFFD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77AF6B6-4A12-4C7A-8030-6C9BC894A5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4AD1C17-E2C4-4CFF-BB6E-AB9662D9D2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64572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29A8FAC-FE6A-4130-A3C5-BA0800FDB4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ED9F49C-7723-4261-9EC6-BB0F23F8F7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D60EDE9-BE75-4900-AD13-3D691B6CE6A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696FF7-876F-4EA9-BBAC-DF2E440F92E8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8673029-6A76-4353-8913-376FE3904F7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BE15938-83DD-4F7E-9CAC-EDDA39E1434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7483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tif"/><Relationship Id="rId4" Type="http://schemas.openxmlformats.org/officeDocument/2006/relationships/image" Target="../media/image1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"/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tif"/><Relationship Id="rId4" Type="http://schemas.openxmlformats.org/officeDocument/2006/relationships/image" Target="../media/image4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15">
            <a:extLst>
              <a:ext uri="{FF2B5EF4-FFF2-40B4-BE49-F238E27FC236}">
                <a16:creationId xmlns:a16="http://schemas.microsoft.com/office/drawing/2014/main" id="{21667687-A96B-4BCA-B684-85102C7C7895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57720" y="2081179"/>
            <a:ext cx="1173162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200" b="1" dirty="0"/>
              <a:t>control</a:t>
            </a: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9D16EFDA-3EEA-4E35-AE8F-9B128CD212AD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7300" y="1740155"/>
            <a:ext cx="185483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200" b="1" dirty="0"/>
              <a:t>Flag-DY +HA-TSC1</a:t>
            </a:r>
          </a:p>
        </p:txBody>
      </p:sp>
      <p:sp>
        <p:nvSpPr>
          <p:cNvPr id="8" name="文本框 15">
            <a:extLst>
              <a:ext uri="{FF2B5EF4-FFF2-40B4-BE49-F238E27FC236}">
                <a16:creationId xmlns:a16="http://schemas.microsoft.com/office/drawing/2014/main" id="{498BD996-5050-4ECA-985E-E07ED9ADCE4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00636" y="1666554"/>
            <a:ext cx="200163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200" b="1" dirty="0"/>
              <a:t>Flag-DY-Del1+HA-TSC1</a:t>
            </a:r>
          </a:p>
        </p:txBody>
      </p:sp>
      <p:sp>
        <p:nvSpPr>
          <p:cNvPr id="9" name="文本框 15">
            <a:extLst>
              <a:ext uri="{FF2B5EF4-FFF2-40B4-BE49-F238E27FC236}">
                <a16:creationId xmlns:a16="http://schemas.microsoft.com/office/drawing/2014/main" id="{78034E0D-16D8-4D45-BAC6-DE1910C1AB4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835646" y="1644920"/>
            <a:ext cx="200163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200" b="1" dirty="0"/>
              <a:t>Flag-DY-Del2+HA-TSC1</a:t>
            </a:r>
          </a:p>
        </p:txBody>
      </p:sp>
      <p:sp>
        <p:nvSpPr>
          <p:cNvPr id="10" name="文本框 15">
            <a:extLst>
              <a:ext uri="{FF2B5EF4-FFF2-40B4-BE49-F238E27FC236}">
                <a16:creationId xmlns:a16="http://schemas.microsoft.com/office/drawing/2014/main" id="{2236F0FF-9141-4892-B60E-870714D2BC25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267626" y="1674164"/>
            <a:ext cx="200163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200" b="1" dirty="0"/>
              <a:t>Flag-DY-Del3+HA-TSC1</a:t>
            </a:r>
          </a:p>
        </p:txBody>
      </p:sp>
      <p:sp>
        <p:nvSpPr>
          <p:cNvPr id="11" name="文本框 15">
            <a:extLst>
              <a:ext uri="{FF2B5EF4-FFF2-40B4-BE49-F238E27FC236}">
                <a16:creationId xmlns:a16="http://schemas.microsoft.com/office/drawing/2014/main" id="{BEFC7680-0247-4C98-B2A8-950E9084FAFA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740516" y="1666553"/>
            <a:ext cx="200163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200" b="1" dirty="0"/>
              <a:t>Flag-DY-Del4+HA-TSC1</a:t>
            </a: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BCF39B04-5D04-4B72-8336-1F42A21562D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187799" y="1644919"/>
            <a:ext cx="200163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200" b="1" dirty="0"/>
              <a:t>Flag-DY-Del5+HA-TSC1</a:t>
            </a:r>
          </a:p>
        </p:txBody>
      </p:sp>
      <p:sp>
        <p:nvSpPr>
          <p:cNvPr id="13" name="文本框 15">
            <a:extLst>
              <a:ext uri="{FF2B5EF4-FFF2-40B4-BE49-F238E27FC236}">
                <a16:creationId xmlns:a16="http://schemas.microsoft.com/office/drawing/2014/main" id="{83201F08-9E29-42BF-9A79-9E1B7893F753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698272" y="1688279"/>
            <a:ext cx="198837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200" b="1" dirty="0"/>
              <a:t>Flag-DY-Del6+HA-TSC1</a:t>
            </a:r>
          </a:p>
        </p:txBody>
      </p:sp>
      <p:sp>
        <p:nvSpPr>
          <p:cNvPr id="14" name="文本框 15">
            <a:extLst>
              <a:ext uri="{FF2B5EF4-FFF2-40B4-BE49-F238E27FC236}">
                <a16:creationId xmlns:a16="http://schemas.microsoft.com/office/drawing/2014/main" id="{8F5B9A03-A7E2-4AA0-BEDF-6E1E5BF0B34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145555" y="1713442"/>
            <a:ext cx="198837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200" b="1" dirty="0"/>
              <a:t>Flag-DY-Del7+HA-TSC1</a:t>
            </a: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9F3590E7-6D25-4829-A66B-F0B554473FB7}"/>
              </a:ext>
            </a:extLst>
          </p:cNvPr>
          <p:cNvSpPr txBox="1"/>
          <p:nvPr/>
        </p:nvSpPr>
        <p:spPr>
          <a:xfrm>
            <a:off x="4383464" y="3000066"/>
            <a:ext cx="98601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α-Flag</a:t>
            </a:r>
            <a:endParaRPr lang="zh-CN" altLang="en-US" b="1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CF53A01A-630D-4CE4-AAC4-929FB3A5AFAE}"/>
              </a:ext>
            </a:extLst>
          </p:cNvPr>
          <p:cNvSpPr txBox="1"/>
          <p:nvPr/>
        </p:nvSpPr>
        <p:spPr>
          <a:xfrm>
            <a:off x="4372002" y="3871438"/>
            <a:ext cx="98601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α-HA</a:t>
            </a:r>
            <a:endParaRPr lang="zh-CN" altLang="en-US" b="1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51532674-03F2-4A88-9DF5-E7F29BC00668}"/>
              </a:ext>
            </a:extLst>
          </p:cNvPr>
          <p:cNvSpPr txBox="1"/>
          <p:nvPr/>
        </p:nvSpPr>
        <p:spPr>
          <a:xfrm>
            <a:off x="4383464" y="4409069"/>
            <a:ext cx="122161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α-ACTIN</a:t>
            </a:r>
            <a:endParaRPr lang="zh-CN" altLang="en-US" b="1" dirty="0"/>
          </a:p>
        </p:txBody>
      </p: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D23CCE44-7FAF-4DDE-9C41-B1203B6AE2F9}"/>
              </a:ext>
            </a:extLst>
          </p:cNvPr>
          <p:cNvCxnSpPr/>
          <p:nvPr/>
        </p:nvCxnSpPr>
        <p:spPr>
          <a:xfrm>
            <a:off x="5570578" y="2896125"/>
            <a:ext cx="0" cy="19771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6DE7D516-EDFA-43BA-81F6-EB67D5F1E59E}"/>
              </a:ext>
            </a:extLst>
          </p:cNvPr>
          <p:cNvSpPr txBox="1"/>
          <p:nvPr/>
        </p:nvSpPr>
        <p:spPr>
          <a:xfrm rot="5400000">
            <a:off x="5358855" y="3597918"/>
            <a:ext cx="86177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Input</a:t>
            </a:r>
            <a:endParaRPr lang="zh-CN" altLang="en-US" b="1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F7975014-9F6A-4A6C-912A-FEA04D85B1A2}"/>
              </a:ext>
            </a:extLst>
          </p:cNvPr>
          <p:cNvSpPr txBox="1"/>
          <p:nvPr/>
        </p:nvSpPr>
        <p:spPr>
          <a:xfrm>
            <a:off x="4372002" y="5327147"/>
            <a:ext cx="98601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α-Flag</a:t>
            </a:r>
            <a:endParaRPr lang="zh-CN" altLang="en-US" b="1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79E8B0CE-1978-4589-BE61-F721DF3A619A}"/>
              </a:ext>
            </a:extLst>
          </p:cNvPr>
          <p:cNvSpPr txBox="1"/>
          <p:nvPr/>
        </p:nvSpPr>
        <p:spPr>
          <a:xfrm>
            <a:off x="4360540" y="6198519"/>
            <a:ext cx="98601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α-HA</a:t>
            </a:r>
            <a:endParaRPr lang="zh-CN" altLang="en-US" b="1" dirty="0"/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194CCF39-E3DD-45FA-8FE8-DB5D0DAB7106}"/>
              </a:ext>
            </a:extLst>
          </p:cNvPr>
          <p:cNvCxnSpPr>
            <a:cxnSpLocks/>
          </p:cNvCxnSpPr>
          <p:nvPr/>
        </p:nvCxnSpPr>
        <p:spPr>
          <a:xfrm>
            <a:off x="5570578" y="5037441"/>
            <a:ext cx="0" cy="153041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A5D69653-8797-4125-981E-2DD25AB95C1C}"/>
              </a:ext>
            </a:extLst>
          </p:cNvPr>
          <p:cNvSpPr txBox="1"/>
          <p:nvPr/>
        </p:nvSpPr>
        <p:spPr>
          <a:xfrm rot="5400000">
            <a:off x="4840479" y="5611155"/>
            <a:ext cx="182953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Flag-beads-IP</a:t>
            </a:r>
            <a:endParaRPr lang="zh-CN" altLang="en-US" b="1" dirty="0"/>
          </a:p>
        </p:txBody>
      </p:sp>
      <p:pic>
        <p:nvPicPr>
          <p:cNvPr id="25" name="图片 24">
            <a:extLst>
              <a:ext uri="{FF2B5EF4-FFF2-40B4-BE49-F238E27FC236}">
                <a16:creationId xmlns:a16="http://schemas.microsoft.com/office/drawing/2014/main" id="{7E02DC80-19B6-49C6-A5A6-D83AFE3E4B2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400" y="3818774"/>
            <a:ext cx="4017816" cy="590295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63A9F7B4-7B36-4B5B-AD3D-EC5EDDB7E6B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903" y="2838563"/>
            <a:ext cx="4083143" cy="922416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C07B0FB3-D3C4-471C-A9B8-6FD3C4346AA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244" y="4492679"/>
            <a:ext cx="4055050" cy="435145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DC5A3D7F-852E-4288-955D-9C0AF1E646A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537" y="5028891"/>
            <a:ext cx="4032464" cy="965147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8952E71D-0DB6-47D6-A3D8-0E16EB1B4E7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903" y="6103052"/>
            <a:ext cx="4138539" cy="608412"/>
          </a:xfrm>
          <a:prstGeom prst="rect">
            <a:avLst/>
          </a:prstGeom>
        </p:spPr>
      </p:pic>
      <p:sp>
        <p:nvSpPr>
          <p:cNvPr id="36" name="文本框 35">
            <a:extLst>
              <a:ext uri="{FF2B5EF4-FFF2-40B4-BE49-F238E27FC236}">
                <a16:creationId xmlns:a16="http://schemas.microsoft.com/office/drawing/2014/main" id="{C5794028-7826-4415-9514-1496077A1C61}"/>
              </a:ext>
            </a:extLst>
          </p:cNvPr>
          <p:cNvSpPr txBox="1"/>
          <p:nvPr/>
        </p:nvSpPr>
        <p:spPr>
          <a:xfrm>
            <a:off x="6463954" y="434900"/>
            <a:ext cx="86177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Input</a:t>
            </a:r>
            <a:endParaRPr lang="zh-CN" altLang="en-US" b="1" dirty="0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49FBB117-9F06-4864-A416-30AEF068C8F8}"/>
              </a:ext>
            </a:extLst>
          </p:cNvPr>
          <p:cNvSpPr txBox="1"/>
          <p:nvPr/>
        </p:nvSpPr>
        <p:spPr>
          <a:xfrm>
            <a:off x="6566289" y="951238"/>
            <a:ext cx="98601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α-Flag</a:t>
            </a:r>
            <a:endParaRPr lang="zh-CN" altLang="en-US" b="1" dirty="0"/>
          </a:p>
        </p:txBody>
      </p:sp>
      <p:pic>
        <p:nvPicPr>
          <p:cNvPr id="39" name="图片 38">
            <a:extLst>
              <a:ext uri="{FF2B5EF4-FFF2-40B4-BE49-F238E27FC236}">
                <a16:creationId xmlns:a16="http://schemas.microsoft.com/office/drawing/2014/main" id="{E7B65588-29DB-42F6-A3F8-717F7B53451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63954" y="1447154"/>
            <a:ext cx="4696248" cy="3480670"/>
          </a:xfrm>
          <a:prstGeom prst="rect">
            <a:avLst/>
          </a:prstGeom>
        </p:spPr>
      </p:pic>
      <p:pic>
        <p:nvPicPr>
          <p:cNvPr id="2" name="图片 26">
            <a:extLst>
              <a:ext uri="{FF2B5EF4-FFF2-40B4-BE49-F238E27FC236}">
                <a16:creationId xmlns:a16="http://schemas.microsoft.com/office/drawing/2014/main" id="{AABA194D-47BF-74AB-5089-6D861F4FAFE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69156" y="4954176"/>
            <a:ext cx="4216690" cy="95258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45FFA7B-B69A-3670-B4CB-17D19BB7DF71}"/>
              </a:ext>
            </a:extLst>
          </p:cNvPr>
          <p:cNvSpPr txBox="1"/>
          <p:nvPr/>
        </p:nvSpPr>
        <p:spPr>
          <a:xfrm>
            <a:off x="6132428" y="3707198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63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83E4B1D-CC81-3618-421B-B342DAD07CBF}"/>
              </a:ext>
            </a:extLst>
          </p:cNvPr>
          <p:cNvSpPr txBox="1"/>
          <p:nvPr/>
        </p:nvSpPr>
        <p:spPr>
          <a:xfrm>
            <a:off x="6132428" y="3152001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75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A898BC3-D502-D1FF-067F-4524D2309320}"/>
              </a:ext>
            </a:extLst>
          </p:cNvPr>
          <p:cNvSpPr txBox="1"/>
          <p:nvPr/>
        </p:nvSpPr>
        <p:spPr>
          <a:xfrm>
            <a:off x="6060788" y="2590937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100</a:t>
            </a:r>
          </a:p>
        </p:txBody>
      </p:sp>
      <p:sp>
        <p:nvSpPr>
          <p:cNvPr id="26" name="文本框 4">
            <a:extLst>
              <a:ext uri="{FF2B5EF4-FFF2-40B4-BE49-F238E27FC236}">
                <a16:creationId xmlns:a16="http://schemas.microsoft.com/office/drawing/2014/main" id="{8775C04E-35C0-63BE-043A-F996B649B51C}"/>
              </a:ext>
            </a:extLst>
          </p:cNvPr>
          <p:cNvSpPr txBox="1"/>
          <p:nvPr/>
        </p:nvSpPr>
        <p:spPr>
          <a:xfrm>
            <a:off x="390748" y="209355"/>
            <a:ext cx="47163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Figure 2-figure </a:t>
            </a:r>
            <a:r>
              <a:rPr lang="en-US" altLang="zh-CN"/>
              <a:t>supplement 2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6248566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16ED3DF7-EC58-4C5F-9772-2D5F87182D13}"/>
              </a:ext>
            </a:extLst>
          </p:cNvPr>
          <p:cNvSpPr txBox="1"/>
          <p:nvPr/>
        </p:nvSpPr>
        <p:spPr>
          <a:xfrm>
            <a:off x="289396" y="408613"/>
            <a:ext cx="86177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Input</a:t>
            </a:r>
            <a:endParaRPr lang="zh-CN" altLang="en-US" b="1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78CA4261-DDF8-419F-B7F8-C1E8D8186353}"/>
              </a:ext>
            </a:extLst>
          </p:cNvPr>
          <p:cNvSpPr txBox="1"/>
          <p:nvPr/>
        </p:nvSpPr>
        <p:spPr>
          <a:xfrm>
            <a:off x="289396" y="1129479"/>
            <a:ext cx="98601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α-HA</a:t>
            </a:r>
            <a:endParaRPr lang="zh-CN" altLang="en-US" b="1" dirty="0"/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CBFA1155-C170-456F-BD2E-E9D0F48B1DB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396" y="1617417"/>
            <a:ext cx="4829281" cy="3160984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333B856A-5C8A-470B-8C14-342589E2C539}"/>
              </a:ext>
            </a:extLst>
          </p:cNvPr>
          <p:cNvSpPr txBox="1"/>
          <p:nvPr/>
        </p:nvSpPr>
        <p:spPr>
          <a:xfrm>
            <a:off x="6344239" y="1111494"/>
            <a:ext cx="122161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α-ACTIN</a:t>
            </a:r>
            <a:endParaRPr lang="zh-CN" altLang="en-US" b="1" dirty="0"/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8541BE88-F410-40EC-9837-C3E092EC6FE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5853" y="1617416"/>
            <a:ext cx="5120793" cy="3160983"/>
          </a:xfrm>
          <a:prstGeom prst="rect">
            <a:avLst/>
          </a:prstGeom>
        </p:spPr>
      </p:pic>
      <p:sp>
        <p:nvSpPr>
          <p:cNvPr id="2" name="文本框 4">
            <a:extLst>
              <a:ext uri="{FF2B5EF4-FFF2-40B4-BE49-F238E27FC236}">
                <a16:creationId xmlns:a16="http://schemas.microsoft.com/office/drawing/2014/main" id="{7494E708-BFE9-CD33-87A3-6B3744775713}"/>
              </a:ext>
            </a:extLst>
          </p:cNvPr>
          <p:cNvSpPr txBox="1"/>
          <p:nvPr/>
        </p:nvSpPr>
        <p:spPr>
          <a:xfrm>
            <a:off x="1229551" y="39281"/>
            <a:ext cx="47163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Supplementary Figure S2B</a:t>
            </a:r>
            <a:endParaRPr lang="zh-CN" altLang="en-US" dirty="0"/>
          </a:p>
        </p:txBody>
      </p:sp>
      <p:pic>
        <p:nvPicPr>
          <p:cNvPr id="3" name="图片 24">
            <a:extLst>
              <a:ext uri="{FF2B5EF4-FFF2-40B4-BE49-F238E27FC236}">
                <a16:creationId xmlns:a16="http://schemas.microsoft.com/office/drawing/2014/main" id="{A14EDCD7-C053-4CFD-F98D-2B883D92505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968" y="4897007"/>
            <a:ext cx="4154136" cy="610323"/>
          </a:xfrm>
          <a:prstGeom prst="rect">
            <a:avLst/>
          </a:prstGeom>
        </p:spPr>
      </p:pic>
      <p:pic>
        <p:nvPicPr>
          <p:cNvPr id="6" name="图片 28">
            <a:extLst>
              <a:ext uri="{FF2B5EF4-FFF2-40B4-BE49-F238E27FC236}">
                <a16:creationId xmlns:a16="http://schemas.microsoft.com/office/drawing/2014/main" id="{A4A74D4A-4EB7-A10F-6B67-70D4C9837D4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46772" y="4823194"/>
            <a:ext cx="4525729" cy="48565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213667ED-474B-7598-34AC-232D5A21227C}"/>
              </a:ext>
            </a:extLst>
          </p:cNvPr>
          <p:cNvSpPr txBox="1"/>
          <p:nvPr/>
        </p:nvSpPr>
        <p:spPr>
          <a:xfrm>
            <a:off x="5610044" y="2733677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6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7149FCE-531A-51E1-A54D-4B2BBEC4C28C}"/>
              </a:ext>
            </a:extLst>
          </p:cNvPr>
          <p:cNvSpPr txBox="1"/>
          <p:nvPr/>
        </p:nvSpPr>
        <p:spPr>
          <a:xfrm>
            <a:off x="5610044" y="2178480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75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216DD10-76DF-8B56-12B3-F9EEDB5905F1}"/>
              </a:ext>
            </a:extLst>
          </p:cNvPr>
          <p:cNvSpPr txBox="1"/>
          <p:nvPr/>
        </p:nvSpPr>
        <p:spPr>
          <a:xfrm>
            <a:off x="5459272" y="3387283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48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A017CEB-4748-D9E4-97E0-FB77AF580B37}"/>
              </a:ext>
            </a:extLst>
          </p:cNvPr>
          <p:cNvSpPr txBox="1"/>
          <p:nvPr/>
        </p:nvSpPr>
        <p:spPr>
          <a:xfrm>
            <a:off x="-92363" y="3202556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10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43C300E-BC8F-C4CA-38CB-2E6F356C5ACB}"/>
              </a:ext>
            </a:extLst>
          </p:cNvPr>
          <p:cNvSpPr txBox="1"/>
          <p:nvPr/>
        </p:nvSpPr>
        <p:spPr>
          <a:xfrm>
            <a:off x="0" y="2644382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13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D9531B8-1137-8007-E9FC-D5FCA22ABECA}"/>
              </a:ext>
            </a:extLst>
          </p:cNvPr>
          <p:cNvSpPr txBox="1"/>
          <p:nvPr/>
        </p:nvSpPr>
        <p:spPr>
          <a:xfrm>
            <a:off x="-71640" y="2271022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180</a:t>
            </a:r>
          </a:p>
        </p:txBody>
      </p:sp>
    </p:spTree>
    <p:extLst>
      <p:ext uri="{BB962C8B-B14F-4D97-AF65-F5344CB8AC3E}">
        <p14:creationId xmlns:p14="http://schemas.microsoft.com/office/powerpoint/2010/main" val="27171833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3192FF42-A1FB-45C3-A89A-1770D5E19FF5}"/>
              </a:ext>
            </a:extLst>
          </p:cNvPr>
          <p:cNvSpPr txBox="1"/>
          <p:nvPr/>
        </p:nvSpPr>
        <p:spPr>
          <a:xfrm>
            <a:off x="607843" y="709218"/>
            <a:ext cx="182953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Flag-beads-IP</a:t>
            </a:r>
            <a:endParaRPr lang="zh-CN" altLang="en-US" b="1" dirty="0"/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85965338-EDD0-4E19-B58A-D2A30EB5FE2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386" t="24632" r="27899" b="32891"/>
          <a:stretch/>
        </p:blipFill>
        <p:spPr>
          <a:xfrm>
            <a:off x="537326" y="1805249"/>
            <a:ext cx="4609999" cy="3289954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55106A72-6A6F-4A73-9DC3-297F3B2A71F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06911" y="1818845"/>
            <a:ext cx="5009248" cy="3276357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656658EA-7443-4CB8-8BD3-292B9792123E}"/>
              </a:ext>
            </a:extLst>
          </p:cNvPr>
          <p:cNvSpPr txBox="1"/>
          <p:nvPr/>
        </p:nvSpPr>
        <p:spPr>
          <a:xfrm>
            <a:off x="537326" y="1328310"/>
            <a:ext cx="98601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α-Flag</a:t>
            </a:r>
            <a:endParaRPr lang="zh-CN" altLang="en-US" b="1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FE11EB67-9483-4131-922B-68B769B9C92D}"/>
              </a:ext>
            </a:extLst>
          </p:cNvPr>
          <p:cNvSpPr txBox="1"/>
          <p:nvPr/>
        </p:nvSpPr>
        <p:spPr>
          <a:xfrm>
            <a:off x="6096000" y="1328310"/>
            <a:ext cx="98601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α-HA</a:t>
            </a:r>
            <a:endParaRPr lang="zh-CN" altLang="en-US" b="1" dirty="0"/>
          </a:p>
        </p:txBody>
      </p:sp>
      <p:sp>
        <p:nvSpPr>
          <p:cNvPr id="2" name="文本框 4">
            <a:extLst>
              <a:ext uri="{FF2B5EF4-FFF2-40B4-BE49-F238E27FC236}">
                <a16:creationId xmlns:a16="http://schemas.microsoft.com/office/drawing/2014/main" id="{329F6DB3-3D20-54FF-E4C7-21243D8AAF02}"/>
              </a:ext>
            </a:extLst>
          </p:cNvPr>
          <p:cNvSpPr txBox="1"/>
          <p:nvPr/>
        </p:nvSpPr>
        <p:spPr>
          <a:xfrm>
            <a:off x="279903" y="329117"/>
            <a:ext cx="47163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Supplementary Figure S2B</a:t>
            </a:r>
            <a:endParaRPr lang="zh-CN" altLang="en-US" dirty="0"/>
          </a:p>
        </p:txBody>
      </p:sp>
      <p:pic>
        <p:nvPicPr>
          <p:cNvPr id="3" name="图片 30">
            <a:extLst>
              <a:ext uri="{FF2B5EF4-FFF2-40B4-BE49-F238E27FC236}">
                <a16:creationId xmlns:a16="http://schemas.microsoft.com/office/drawing/2014/main" id="{5ACDAA32-208C-50DA-5FAB-182D1179469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4643" y="5183635"/>
            <a:ext cx="4254826" cy="1018368"/>
          </a:xfrm>
          <a:prstGeom prst="rect">
            <a:avLst/>
          </a:prstGeom>
        </p:spPr>
      </p:pic>
      <p:pic>
        <p:nvPicPr>
          <p:cNvPr id="5" name="图片 34">
            <a:extLst>
              <a:ext uri="{FF2B5EF4-FFF2-40B4-BE49-F238E27FC236}">
                <a16:creationId xmlns:a16="http://schemas.microsoft.com/office/drawing/2014/main" id="{383FC821-00A8-B9FB-70EB-3D1F76C8DA2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4242" y="5095202"/>
            <a:ext cx="4414586" cy="64899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3091A8B-65D9-B30A-EC82-6CB46EE72F2F}"/>
              </a:ext>
            </a:extLst>
          </p:cNvPr>
          <p:cNvSpPr txBox="1"/>
          <p:nvPr/>
        </p:nvSpPr>
        <p:spPr>
          <a:xfrm>
            <a:off x="5420265" y="2763927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18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48F415F-F917-6F52-0D8C-27B942F94C3A}"/>
              </a:ext>
            </a:extLst>
          </p:cNvPr>
          <p:cNvSpPr txBox="1"/>
          <p:nvPr/>
        </p:nvSpPr>
        <p:spPr>
          <a:xfrm>
            <a:off x="5420265" y="4540005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7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DB774AC-9C42-E416-B5C6-1AED1DE5B220}"/>
              </a:ext>
            </a:extLst>
          </p:cNvPr>
          <p:cNvSpPr txBox="1"/>
          <p:nvPr/>
        </p:nvSpPr>
        <p:spPr>
          <a:xfrm>
            <a:off x="5348625" y="3978941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100</a:t>
            </a:r>
          </a:p>
        </p:txBody>
      </p:sp>
    </p:spTree>
    <p:extLst>
      <p:ext uri="{BB962C8B-B14F-4D97-AF65-F5344CB8AC3E}">
        <p14:creationId xmlns:p14="http://schemas.microsoft.com/office/powerpoint/2010/main" val="8700253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42</TotalTime>
  <Words>62</Words>
  <Application>Microsoft Office PowerPoint</Application>
  <PresentationFormat>Widescreen</PresentationFormat>
  <Paragraphs>3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DengXian</vt:lpstr>
      <vt:lpstr>DengXian Light</vt:lpstr>
      <vt:lpstr>Arial</vt:lpstr>
      <vt:lpstr>Office 主题​​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inhua Wang</dc:creator>
  <cp:lastModifiedBy>Mohan, Man</cp:lastModifiedBy>
  <cp:revision>18</cp:revision>
  <dcterms:created xsi:type="dcterms:W3CDTF">2022-02-25T12:50:45Z</dcterms:created>
  <dcterms:modified xsi:type="dcterms:W3CDTF">2024-10-11T03:41:31Z</dcterms:modified>
</cp:coreProperties>
</file>